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7" r:id="rId5"/>
    <p:sldId id="26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lke Seibold" initials="SS" lastIdx="6" clrIdx="0">
    <p:extLst>
      <p:ext uri="{19B8F6BF-5375-455C-9EA6-DF929625EA0E}">
        <p15:presenceInfo xmlns:p15="http://schemas.microsoft.com/office/powerpoint/2012/main" userId="S-1-5-21-2139465200-495060025-2449941776-118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6509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5480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8216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558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618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8363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2489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6944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510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5921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1946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04B71-1E32-43EA-86C2-C5E608F12C82}" type="datetimeFigureOut">
              <a:rPr lang="de-DE" smtClean="0"/>
              <a:t>09.06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69CAC-AC89-4196-ADD5-02443894D52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5731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13" Type="http://schemas.openxmlformats.org/officeDocument/2006/relationships/image" Target="../media/image27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image" Target="../media/image16.jpeg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5" Type="http://schemas.openxmlformats.org/officeDocument/2006/relationships/image" Target="../media/image2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Relationship Id="rId14" Type="http://schemas.openxmlformats.org/officeDocument/2006/relationships/image" Target="../media/image2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eg"/><Relationship Id="rId13" Type="http://schemas.openxmlformats.org/officeDocument/2006/relationships/image" Target="../media/image42.jpeg"/><Relationship Id="rId3" Type="http://schemas.openxmlformats.org/officeDocument/2006/relationships/image" Target="../media/image32.jpeg"/><Relationship Id="rId7" Type="http://schemas.openxmlformats.org/officeDocument/2006/relationships/image" Target="../media/image36.jpeg"/><Relationship Id="rId12" Type="http://schemas.openxmlformats.org/officeDocument/2006/relationships/image" Target="../media/image41.jpeg"/><Relationship Id="rId2" Type="http://schemas.openxmlformats.org/officeDocument/2006/relationships/image" Target="../media/image31.jpeg"/><Relationship Id="rId16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eg"/><Relationship Id="rId11" Type="http://schemas.openxmlformats.org/officeDocument/2006/relationships/image" Target="../media/image40.jpeg"/><Relationship Id="rId5" Type="http://schemas.openxmlformats.org/officeDocument/2006/relationships/image" Target="../media/image34.jpeg"/><Relationship Id="rId15" Type="http://schemas.openxmlformats.org/officeDocument/2006/relationships/image" Target="../media/image44.jpeg"/><Relationship Id="rId10" Type="http://schemas.openxmlformats.org/officeDocument/2006/relationships/image" Target="../media/image39.jpeg"/><Relationship Id="rId4" Type="http://schemas.openxmlformats.org/officeDocument/2006/relationships/image" Target="../media/image33.jpeg"/><Relationship Id="rId9" Type="http://schemas.openxmlformats.org/officeDocument/2006/relationships/image" Target="../media/image38.jpeg"/><Relationship Id="rId14" Type="http://schemas.openxmlformats.org/officeDocument/2006/relationships/image" Target="../media/image43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jpeg"/><Relationship Id="rId13" Type="http://schemas.openxmlformats.org/officeDocument/2006/relationships/image" Target="../media/image57.jpeg"/><Relationship Id="rId3" Type="http://schemas.openxmlformats.org/officeDocument/2006/relationships/image" Target="../media/image47.jpeg"/><Relationship Id="rId7" Type="http://schemas.openxmlformats.org/officeDocument/2006/relationships/image" Target="../media/image51.jpeg"/><Relationship Id="rId12" Type="http://schemas.openxmlformats.org/officeDocument/2006/relationships/image" Target="../media/image56.jpeg"/><Relationship Id="rId2" Type="http://schemas.openxmlformats.org/officeDocument/2006/relationships/image" Target="../media/image46.jpeg"/><Relationship Id="rId16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eg"/><Relationship Id="rId11" Type="http://schemas.openxmlformats.org/officeDocument/2006/relationships/image" Target="../media/image55.jpeg"/><Relationship Id="rId5" Type="http://schemas.openxmlformats.org/officeDocument/2006/relationships/image" Target="../media/image49.jpeg"/><Relationship Id="rId15" Type="http://schemas.openxmlformats.org/officeDocument/2006/relationships/image" Target="../media/image59.jpeg"/><Relationship Id="rId10" Type="http://schemas.openxmlformats.org/officeDocument/2006/relationships/image" Target="../media/image54.jpeg"/><Relationship Id="rId4" Type="http://schemas.openxmlformats.org/officeDocument/2006/relationships/image" Target="../media/image48.jpeg"/><Relationship Id="rId9" Type="http://schemas.openxmlformats.org/officeDocument/2006/relationships/image" Target="../media/image53.jpeg"/><Relationship Id="rId14" Type="http://schemas.openxmlformats.org/officeDocument/2006/relationships/image" Target="../media/image5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13" Type="http://schemas.openxmlformats.org/officeDocument/2006/relationships/image" Target="../media/image27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image" Target="../media/image16.jpeg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5" Type="http://schemas.openxmlformats.org/officeDocument/2006/relationships/image" Target="../media/image2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Relationship Id="rId14" Type="http://schemas.openxmlformats.org/officeDocument/2006/relationships/image" Target="../media/image2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Grafik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846" y="5539719"/>
            <a:ext cx="2329301" cy="125160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" y="5539719"/>
            <a:ext cx="2329301" cy="1251606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" y="109728"/>
            <a:ext cx="2329301" cy="1251606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846" y="109728"/>
            <a:ext cx="2329301" cy="125160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759107" y="112460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D20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" y="1468606"/>
            <a:ext cx="2329301" cy="125160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846" y="1468606"/>
            <a:ext cx="2329301" cy="1251606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1759106" y="1443447"/>
            <a:ext cx="731917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cl</a:t>
            </a:r>
            <a:r>
              <a:rPr lang="de-DE" sz="1600" dirty="0"/>
              <a:t>-X</a:t>
            </a: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846" y="2859407"/>
            <a:ext cx="2329301" cy="1251606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" y="2827484"/>
            <a:ext cx="2329301" cy="1251606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1759107" y="2862139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OX-2</a:t>
            </a: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" y="4183497"/>
            <a:ext cx="2329301" cy="1251815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846" y="4183497"/>
            <a:ext cx="2329301" cy="1251815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1759107" y="4168161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TEN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873407" y="5507796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ax</a:t>
            </a:r>
            <a:endParaRPr lang="de-DE" sz="1600" dirty="0"/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5872" y="109728"/>
            <a:ext cx="2329301" cy="1251606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1899" y="109728"/>
            <a:ext cx="2329301" cy="1251606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6539983" y="109728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MTAP</a:t>
            </a:r>
          </a:p>
        </p:txBody>
      </p:sp>
      <p:pic>
        <p:nvPicPr>
          <p:cNvPr id="21" name="Grafik 2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1899" y="1468606"/>
            <a:ext cx="2329301" cy="1251606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5872" y="1468606"/>
            <a:ext cx="2329301" cy="1251606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6283582" y="1443447"/>
            <a:ext cx="1117328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β</a:t>
            </a:r>
            <a:r>
              <a:rPr lang="de-DE" sz="1600" dirty="0"/>
              <a:t>-</a:t>
            </a:r>
            <a:r>
              <a:rPr lang="de-DE" sz="1600" dirty="0" err="1"/>
              <a:t>Catenin</a:t>
            </a:r>
            <a:endParaRPr lang="de-DE" sz="1600" dirty="0"/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96233" y="3770143"/>
            <a:ext cx="4751331" cy="3077821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6419850" y="3770141"/>
            <a:ext cx="20669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Risk</a:t>
            </a:r>
            <a:r>
              <a:rPr lang="de-DE" sz="1400" dirty="0" smtClean="0"/>
              <a:t> score</a:t>
            </a:r>
            <a:r>
              <a:rPr lang="de-DE" sz="1400" dirty="0"/>
              <a:t>: </a:t>
            </a:r>
            <a:r>
              <a:rPr lang="de-DE" sz="1400" dirty="0">
                <a:solidFill>
                  <a:srgbClr val="FF0000"/>
                </a:solidFill>
              </a:rPr>
              <a:t>0,228 (HR)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9250629" y="1489618"/>
            <a:ext cx="324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4422142" y="4155873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2+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4422142" y="109728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4422142" y="1475561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422142" y="285940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4422142" y="5540253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9193479" y="11247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18140D42-696C-4A43-964D-7C850AEA388A}"/>
              </a:ext>
            </a:extLst>
          </p:cNvPr>
          <p:cNvSpPr txBox="1"/>
          <p:nvPr/>
        </p:nvSpPr>
        <p:spPr>
          <a:xfrm>
            <a:off x="5158848" y="2966171"/>
            <a:ext cx="536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983-08: Pat f, 48y, SSM, 4 mm, </a:t>
            </a:r>
            <a:r>
              <a:rPr lang="de-DE" sz="1400" dirty="0" err="1"/>
              <a:t>ulceration</a:t>
            </a:r>
            <a:r>
              <a:rPr lang="de-DE" sz="1400" dirty="0"/>
              <a:t>, Clark III, pT3b, IIB</a:t>
            </a:r>
          </a:p>
          <a:p>
            <a:r>
              <a:rPr lang="de-DE" sz="1400" dirty="0"/>
              <a:t>MSS 30m, DMFS 20m, RFS 20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25A11E5-9DAC-6E4D-9E72-9683CB6AD211}"/>
              </a:ext>
            </a:extLst>
          </p:cNvPr>
          <p:cNvSpPr txBox="1"/>
          <p:nvPr/>
        </p:nvSpPr>
        <p:spPr>
          <a:xfrm>
            <a:off x="9647564" y="125116"/>
            <a:ext cx="230236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s, </a:t>
            </a:r>
            <a:r>
              <a:rPr lang="de-DE" b="1" dirty="0" err="1"/>
              <a:t>Figure</a:t>
            </a:r>
            <a:r>
              <a:rPr lang="de-DE" b="1" dirty="0"/>
              <a:t> 1</a:t>
            </a:r>
          </a:p>
          <a:p>
            <a:r>
              <a:rPr lang="en-US" dirty="0"/>
              <a:t>7-marker-signature </a:t>
            </a:r>
          </a:p>
          <a:p>
            <a:r>
              <a:rPr lang="en-US" dirty="0"/>
              <a:t>High-risk</a:t>
            </a:r>
          </a:p>
        </p:txBody>
      </p:sp>
    </p:spTree>
    <p:extLst>
      <p:ext uri="{BB962C8B-B14F-4D97-AF65-F5344CB8AC3E}">
        <p14:creationId xmlns:p14="http://schemas.microsoft.com/office/powerpoint/2010/main" val="26871689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70056"/>
            <a:ext cx="2210824" cy="12528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70056"/>
            <a:ext cx="2210824" cy="12528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14880" y="1439238"/>
            <a:ext cx="2210824" cy="12528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442708" y="1439238"/>
            <a:ext cx="2210824" cy="12528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2808420"/>
            <a:ext cx="2210824" cy="12528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2808420"/>
            <a:ext cx="2210824" cy="12528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4177602"/>
            <a:ext cx="2210822" cy="12528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4177602"/>
            <a:ext cx="2210822" cy="12528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5546784"/>
            <a:ext cx="2210824" cy="12528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5546784"/>
            <a:ext cx="2210824" cy="12528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536" y="70056"/>
            <a:ext cx="2210824" cy="12528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8364" y="70056"/>
            <a:ext cx="2210824" cy="12528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536" y="1439238"/>
            <a:ext cx="2210822" cy="125280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8362" y="1445293"/>
            <a:ext cx="2210822" cy="1252800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1710790" y="70056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D20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710789" y="1401043"/>
            <a:ext cx="731917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cl</a:t>
            </a:r>
            <a:r>
              <a:rPr lang="de-DE" sz="1600" dirty="0"/>
              <a:t>-X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1710790" y="2819735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OX-2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1710790" y="4143009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TEN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825090" y="5491270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ax</a:t>
            </a:r>
            <a:endParaRPr lang="de-DE" sz="1600" dirty="0"/>
          </a:p>
        </p:txBody>
      </p:sp>
      <p:sp>
        <p:nvSpPr>
          <p:cNvPr id="21" name="Textfeld 20"/>
          <p:cNvSpPr txBox="1"/>
          <p:nvPr/>
        </p:nvSpPr>
        <p:spPr>
          <a:xfrm>
            <a:off x="6253129" y="67324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MTAP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5996728" y="1401043"/>
            <a:ext cx="1117328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β</a:t>
            </a:r>
            <a:r>
              <a:rPr lang="de-DE" sz="1600" dirty="0"/>
              <a:t>-</a:t>
            </a:r>
            <a:r>
              <a:rPr lang="de-DE" sz="1600" dirty="0" err="1"/>
              <a:t>Catenin</a:t>
            </a:r>
            <a:endParaRPr lang="de-DE" sz="1600" dirty="0"/>
          </a:p>
        </p:txBody>
      </p:sp>
      <p:sp>
        <p:nvSpPr>
          <p:cNvPr id="23" name="Textfeld 22"/>
          <p:cNvSpPr txBox="1"/>
          <p:nvPr/>
        </p:nvSpPr>
        <p:spPr>
          <a:xfrm>
            <a:off x="8898663" y="1447214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222213" y="4152782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222213" y="67324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4222213" y="143315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4296089" y="2808420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4222213" y="552372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8898664" y="70073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27208" y="3887914"/>
            <a:ext cx="4546836" cy="2945353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6282620" y="3881857"/>
            <a:ext cx="20669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Risk</a:t>
            </a:r>
            <a:r>
              <a:rPr lang="de-DE" sz="1400" dirty="0" smtClean="0"/>
              <a:t> score</a:t>
            </a:r>
            <a:r>
              <a:rPr lang="de-DE" sz="1400" dirty="0"/>
              <a:t>: </a:t>
            </a:r>
            <a:r>
              <a:rPr lang="de-DE" sz="1400" dirty="0">
                <a:solidFill>
                  <a:srgbClr val="00B050"/>
                </a:solidFill>
              </a:rPr>
              <a:t>0,099 (LR)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81EA34B1-2A39-4D4D-8344-097EA281E801}"/>
              </a:ext>
            </a:extLst>
          </p:cNvPr>
          <p:cNvSpPr txBox="1"/>
          <p:nvPr/>
        </p:nvSpPr>
        <p:spPr>
          <a:xfrm>
            <a:off x="4960068" y="2952919"/>
            <a:ext cx="536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799-10: Pat w, 51y, UNK, 3,9 mm, </a:t>
            </a:r>
            <a:r>
              <a:rPr lang="de-DE" sz="1400" dirty="0" err="1"/>
              <a:t>ulceration</a:t>
            </a:r>
            <a:r>
              <a:rPr lang="de-DE" sz="1400" dirty="0"/>
              <a:t>, Clark III, pT3b, pN1a, IIIC</a:t>
            </a:r>
          </a:p>
          <a:p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event</a:t>
            </a:r>
            <a:r>
              <a:rPr lang="de-DE" sz="1400" dirty="0"/>
              <a:t> 114m, follow-</a:t>
            </a:r>
            <a:r>
              <a:rPr lang="de-DE" sz="1400" dirty="0" err="1"/>
              <a:t>up</a:t>
            </a:r>
            <a:endParaRPr lang="de-DE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D427FAE-8CF4-8143-9B9D-1FA79AB8806B}"/>
              </a:ext>
            </a:extLst>
          </p:cNvPr>
          <p:cNvSpPr txBox="1"/>
          <p:nvPr/>
        </p:nvSpPr>
        <p:spPr>
          <a:xfrm>
            <a:off x="9422507" y="82712"/>
            <a:ext cx="230236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s, </a:t>
            </a:r>
            <a:r>
              <a:rPr lang="de-DE" b="1" dirty="0" err="1"/>
              <a:t>Figure</a:t>
            </a:r>
            <a:r>
              <a:rPr lang="de-DE" b="1" dirty="0"/>
              <a:t> 2</a:t>
            </a:r>
          </a:p>
          <a:p>
            <a:r>
              <a:rPr lang="en-US" dirty="0"/>
              <a:t>7-marker-signature </a:t>
            </a:r>
          </a:p>
          <a:p>
            <a:r>
              <a:rPr lang="en-US" dirty="0"/>
              <a:t>Low-risk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54614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40" y="85852"/>
            <a:ext cx="2210824" cy="12528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22" y="85852"/>
            <a:ext cx="2210824" cy="12528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40" y="1449147"/>
            <a:ext cx="2210823" cy="12528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22" y="1449147"/>
            <a:ext cx="2210823" cy="12528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40" y="2812443"/>
            <a:ext cx="2196097" cy="124445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548" y="2812442"/>
            <a:ext cx="2196097" cy="1244455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40" y="4167393"/>
            <a:ext cx="2210823" cy="12528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21" y="4167393"/>
            <a:ext cx="2210823" cy="12528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40" y="5530688"/>
            <a:ext cx="2196097" cy="1244455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821" y="5530688"/>
            <a:ext cx="2196097" cy="1244455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204" y="85852"/>
            <a:ext cx="2210824" cy="12528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9586" y="85852"/>
            <a:ext cx="2210823" cy="12528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204" y="1449146"/>
            <a:ext cx="2210824" cy="1252801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9586" y="1449146"/>
            <a:ext cx="2210824" cy="1252801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1852304" y="48284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D20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874075" y="1401043"/>
            <a:ext cx="731917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cl</a:t>
            </a:r>
            <a:r>
              <a:rPr lang="de-DE" sz="1600" dirty="0"/>
              <a:t>-X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1819646" y="2797963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OX-2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1852304" y="4132123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TEN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944832" y="5491270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ax</a:t>
            </a:r>
            <a:endParaRPr lang="de-DE" sz="1600" dirty="0"/>
          </a:p>
        </p:txBody>
      </p:sp>
      <p:sp>
        <p:nvSpPr>
          <p:cNvPr id="21" name="Textfeld 20"/>
          <p:cNvSpPr txBox="1"/>
          <p:nvPr/>
        </p:nvSpPr>
        <p:spPr>
          <a:xfrm>
            <a:off x="6557927" y="89096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MTAP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6225329" y="1433701"/>
            <a:ext cx="1117328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β</a:t>
            </a:r>
            <a:r>
              <a:rPr lang="de-DE" sz="1600" dirty="0"/>
              <a:t>-</a:t>
            </a:r>
            <a:r>
              <a:rPr lang="de-DE" sz="1600" dirty="0" err="1"/>
              <a:t>Catenin</a:t>
            </a:r>
            <a:endParaRPr lang="de-DE" sz="1600" dirty="0"/>
          </a:p>
        </p:txBody>
      </p:sp>
      <p:sp>
        <p:nvSpPr>
          <p:cNvPr id="23" name="Textfeld 22"/>
          <p:cNvSpPr txBox="1"/>
          <p:nvPr/>
        </p:nvSpPr>
        <p:spPr>
          <a:xfrm>
            <a:off x="9196923" y="1425442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472587" y="4131010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2+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472587" y="45552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4472587" y="1411385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4472587" y="2786648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4472587" y="5501955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9196924" y="48301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994203" y="3834893"/>
            <a:ext cx="4677168" cy="3029780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6544279" y="3848770"/>
            <a:ext cx="20669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Risk</a:t>
            </a:r>
            <a:r>
              <a:rPr lang="de-DE" sz="1400" dirty="0" smtClean="0"/>
              <a:t> score</a:t>
            </a:r>
            <a:r>
              <a:rPr lang="de-DE" sz="1400" dirty="0"/>
              <a:t>: </a:t>
            </a:r>
            <a:r>
              <a:rPr lang="de-DE" sz="1400" dirty="0">
                <a:solidFill>
                  <a:srgbClr val="FF0000"/>
                </a:solidFill>
              </a:rPr>
              <a:t>0,163 (HR)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A39E24A0-183A-4F02-80A0-BDF8661A58F3}"/>
              </a:ext>
            </a:extLst>
          </p:cNvPr>
          <p:cNvSpPr txBox="1"/>
          <p:nvPr/>
        </p:nvSpPr>
        <p:spPr>
          <a:xfrm>
            <a:off x="5158848" y="2966178"/>
            <a:ext cx="536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3296-13: Pat m, 78y, NM, 2,5 mm,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ulceration</a:t>
            </a:r>
            <a:r>
              <a:rPr lang="de-DE" sz="1400" dirty="0"/>
              <a:t>, Clark IV, pT3a, IIA</a:t>
            </a:r>
          </a:p>
          <a:p>
            <a:r>
              <a:rPr lang="de-DE" sz="1400" dirty="0"/>
              <a:t>MSS 30m, DMFS 17m, RFS 17m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D54A544-BEBE-DC48-BB14-FA1A97AAE1C1}"/>
              </a:ext>
            </a:extLst>
          </p:cNvPr>
          <p:cNvSpPr txBox="1"/>
          <p:nvPr/>
        </p:nvSpPr>
        <p:spPr>
          <a:xfrm>
            <a:off x="9647564" y="125116"/>
            <a:ext cx="230236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s, </a:t>
            </a:r>
            <a:r>
              <a:rPr lang="de-DE" b="1" dirty="0" err="1"/>
              <a:t>Figure</a:t>
            </a:r>
            <a:r>
              <a:rPr lang="de-DE" b="1"/>
              <a:t> </a:t>
            </a:r>
            <a:r>
              <a:rPr lang="de-DE" b="1" dirty="0"/>
              <a:t>3</a:t>
            </a:r>
          </a:p>
          <a:p>
            <a:r>
              <a:rPr lang="en-US" dirty="0"/>
              <a:t>7-marker-signature </a:t>
            </a:r>
          </a:p>
          <a:p>
            <a:r>
              <a:rPr lang="en-US" dirty="0"/>
              <a:t>High-risk</a:t>
            </a:r>
          </a:p>
        </p:txBody>
      </p:sp>
    </p:spTree>
    <p:extLst>
      <p:ext uri="{BB962C8B-B14F-4D97-AF65-F5344CB8AC3E}">
        <p14:creationId xmlns:p14="http://schemas.microsoft.com/office/powerpoint/2010/main" val="37836948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113180"/>
            <a:ext cx="2274834" cy="124737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465" y="113180"/>
            <a:ext cx="2274834" cy="1247165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727361" y="111644"/>
            <a:ext cx="735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D20</a:t>
            </a: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465" y="1476563"/>
            <a:ext cx="2274834" cy="124716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1476356"/>
            <a:ext cx="2274833" cy="1247373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1727360" y="1486091"/>
            <a:ext cx="7355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cl</a:t>
            </a:r>
            <a:r>
              <a:rPr lang="de-DE" sz="1600" dirty="0"/>
              <a:t>-X</a:t>
            </a: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2829046"/>
            <a:ext cx="2274833" cy="1247373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465" y="2830297"/>
            <a:ext cx="2274833" cy="1247165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1727361" y="2838168"/>
            <a:ext cx="735549" cy="347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OX-2</a:t>
            </a: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4181736"/>
            <a:ext cx="2274833" cy="1247373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465" y="4181736"/>
            <a:ext cx="2274833" cy="1247373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1727361" y="4179650"/>
            <a:ext cx="735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TEN</a:t>
            </a: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5534427"/>
            <a:ext cx="2274833" cy="1247373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465" y="5533383"/>
            <a:ext cx="2274833" cy="1247373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1849281" y="5533383"/>
            <a:ext cx="735549" cy="347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ax</a:t>
            </a:r>
            <a:endParaRPr lang="de-DE" sz="1600" dirty="0"/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2730" y="112972"/>
            <a:ext cx="2274833" cy="124737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5996" y="113180"/>
            <a:ext cx="2274833" cy="1247165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6373479" y="111644"/>
            <a:ext cx="735549" cy="347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MTAP</a:t>
            </a: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2730" y="1485475"/>
            <a:ext cx="2274833" cy="1247373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5996" y="1485683"/>
            <a:ext cx="2274833" cy="1247165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6093377" y="1476356"/>
            <a:ext cx="1122874" cy="347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β</a:t>
            </a:r>
            <a:r>
              <a:rPr lang="de-DE" sz="1600" dirty="0"/>
              <a:t>-</a:t>
            </a:r>
            <a:r>
              <a:rPr lang="de-DE" sz="1600" dirty="0" err="1"/>
              <a:t>Catenin</a:t>
            </a:r>
            <a:endParaRPr lang="de-DE" sz="1600" dirty="0"/>
          </a:p>
        </p:txBody>
      </p:sp>
      <p:sp>
        <p:nvSpPr>
          <p:cNvPr id="30" name="Textfeld 29"/>
          <p:cNvSpPr txBox="1"/>
          <p:nvPr/>
        </p:nvSpPr>
        <p:spPr>
          <a:xfrm>
            <a:off x="4329879" y="111644"/>
            <a:ext cx="735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4329879" y="1498791"/>
            <a:ext cx="290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329879" y="2821801"/>
            <a:ext cx="2902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4329879" y="4183351"/>
            <a:ext cx="394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2+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329879" y="5544157"/>
            <a:ext cx="394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8956000" y="120336"/>
            <a:ext cx="394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8956000" y="1472518"/>
            <a:ext cx="394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pic>
        <p:nvPicPr>
          <p:cNvPr id="37" name="Grafik 3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45650" y="3700668"/>
            <a:ext cx="4505180" cy="3154790"/>
          </a:xfrm>
          <a:prstGeom prst="rect">
            <a:avLst/>
          </a:prstGeom>
        </p:spPr>
      </p:pic>
      <p:sp>
        <p:nvSpPr>
          <p:cNvPr id="40" name="Textfeld 39"/>
          <p:cNvSpPr txBox="1"/>
          <p:nvPr/>
        </p:nvSpPr>
        <p:spPr>
          <a:xfrm>
            <a:off x="6323959" y="3687416"/>
            <a:ext cx="180086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Risk</a:t>
            </a:r>
            <a:r>
              <a:rPr lang="de-DE" sz="1400" dirty="0" smtClean="0"/>
              <a:t> score</a:t>
            </a:r>
            <a:r>
              <a:rPr lang="de-DE" sz="1400" dirty="0"/>
              <a:t>: </a:t>
            </a:r>
            <a:r>
              <a:rPr lang="de-DE" sz="1400" dirty="0">
                <a:solidFill>
                  <a:srgbClr val="00B050"/>
                </a:solidFill>
              </a:rPr>
              <a:t>0,130 (LR)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FD6C25F3-0DAD-4D1D-AFDC-3137E7981363}"/>
              </a:ext>
            </a:extLst>
          </p:cNvPr>
          <p:cNvSpPr txBox="1"/>
          <p:nvPr/>
        </p:nvSpPr>
        <p:spPr>
          <a:xfrm>
            <a:off x="4986572" y="2952919"/>
            <a:ext cx="536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2108-07: Pat m, 90y, NM, 3,4 mm, </a:t>
            </a:r>
            <a:r>
              <a:rPr lang="de-DE" sz="1400" dirty="0" err="1"/>
              <a:t>ulceration</a:t>
            </a:r>
            <a:r>
              <a:rPr lang="de-DE" sz="1400" dirty="0"/>
              <a:t>, Clark V, pT3b, IIB</a:t>
            </a:r>
          </a:p>
          <a:p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event</a:t>
            </a:r>
            <a:r>
              <a:rPr lang="de-DE" sz="1400" dirty="0"/>
              <a:t> 60m, Pat </a:t>
            </a:r>
            <a:r>
              <a:rPr lang="de-DE" sz="1400" dirty="0" err="1"/>
              <a:t>died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other</a:t>
            </a:r>
            <a:r>
              <a:rPr lang="de-DE" sz="1400" dirty="0"/>
              <a:t> </a:t>
            </a:r>
            <a:r>
              <a:rPr lang="de-DE" sz="1400" dirty="0" err="1"/>
              <a:t>cause</a:t>
            </a:r>
            <a:endParaRPr lang="de-DE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5880930-E92E-2948-851F-1CE4EB437859}"/>
              </a:ext>
            </a:extLst>
          </p:cNvPr>
          <p:cNvSpPr txBox="1"/>
          <p:nvPr/>
        </p:nvSpPr>
        <p:spPr>
          <a:xfrm>
            <a:off x="9422507" y="82712"/>
            <a:ext cx="230236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s, </a:t>
            </a:r>
            <a:r>
              <a:rPr lang="de-DE" b="1" dirty="0" err="1"/>
              <a:t>Figure</a:t>
            </a:r>
            <a:r>
              <a:rPr lang="de-DE" b="1" dirty="0"/>
              <a:t> 4</a:t>
            </a:r>
          </a:p>
          <a:p>
            <a:r>
              <a:rPr lang="en-US" dirty="0"/>
              <a:t>7-marker-signature </a:t>
            </a:r>
          </a:p>
          <a:p>
            <a:r>
              <a:rPr lang="en-US" dirty="0"/>
              <a:t>Low-risk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9266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70056"/>
            <a:ext cx="2210824" cy="12528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70056"/>
            <a:ext cx="2210824" cy="12528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14880" y="1439238"/>
            <a:ext cx="2210824" cy="12528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442708" y="1439238"/>
            <a:ext cx="2210824" cy="12528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2808420"/>
            <a:ext cx="2210824" cy="12528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2808420"/>
            <a:ext cx="2210824" cy="12528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4177602"/>
            <a:ext cx="2210822" cy="12528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4177602"/>
            <a:ext cx="2210822" cy="12528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80" y="5546784"/>
            <a:ext cx="2210824" cy="12528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708" y="5546784"/>
            <a:ext cx="2210824" cy="12528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536" y="70056"/>
            <a:ext cx="2210824" cy="12528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8364" y="70056"/>
            <a:ext cx="2210824" cy="12528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536" y="1439238"/>
            <a:ext cx="2210822" cy="125280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8362" y="1445293"/>
            <a:ext cx="2210822" cy="1252800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1710790" y="70056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D20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710789" y="1401043"/>
            <a:ext cx="731917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cl</a:t>
            </a:r>
            <a:r>
              <a:rPr lang="de-DE" sz="1600" dirty="0"/>
              <a:t>-X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1710790" y="2819735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OX-2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1710790" y="4143009"/>
            <a:ext cx="731916" cy="319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PTEN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825090" y="5491270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Bax</a:t>
            </a:r>
            <a:endParaRPr lang="de-DE" sz="1600" dirty="0"/>
          </a:p>
        </p:txBody>
      </p:sp>
      <p:sp>
        <p:nvSpPr>
          <p:cNvPr id="21" name="Textfeld 20"/>
          <p:cNvSpPr txBox="1"/>
          <p:nvPr/>
        </p:nvSpPr>
        <p:spPr>
          <a:xfrm>
            <a:off x="6253129" y="67324"/>
            <a:ext cx="731916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MTAP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5996728" y="1401043"/>
            <a:ext cx="1117328" cy="327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/>
              <a:t>β</a:t>
            </a:r>
            <a:r>
              <a:rPr lang="de-DE" sz="1600" dirty="0"/>
              <a:t>-</a:t>
            </a:r>
            <a:r>
              <a:rPr lang="de-DE" sz="1600" dirty="0" err="1"/>
              <a:t>Catenin</a:t>
            </a:r>
            <a:endParaRPr lang="de-DE" sz="1600" dirty="0"/>
          </a:p>
        </p:txBody>
      </p:sp>
      <p:sp>
        <p:nvSpPr>
          <p:cNvPr id="23" name="Textfeld 22"/>
          <p:cNvSpPr txBox="1"/>
          <p:nvPr/>
        </p:nvSpPr>
        <p:spPr>
          <a:xfrm>
            <a:off x="8898663" y="1447214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222213" y="4152782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222213" y="67324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4222213" y="143315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4296089" y="2808420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0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4222213" y="5523727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8898664" y="70073"/>
            <a:ext cx="474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1+</a:t>
            </a: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27208" y="3887914"/>
            <a:ext cx="4546836" cy="2945353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6282620" y="3881857"/>
            <a:ext cx="20669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 err="1" smtClean="0"/>
              <a:t>Risk</a:t>
            </a:r>
            <a:r>
              <a:rPr lang="de-DE" sz="1400" dirty="0" smtClean="0"/>
              <a:t> score</a:t>
            </a:r>
            <a:r>
              <a:rPr lang="de-DE" sz="1400" dirty="0"/>
              <a:t>: </a:t>
            </a:r>
            <a:r>
              <a:rPr lang="de-DE" sz="1400" dirty="0">
                <a:solidFill>
                  <a:srgbClr val="00B050"/>
                </a:solidFill>
              </a:rPr>
              <a:t>0,099 (LR)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81EA34B1-2A39-4D4D-8344-097EA281E801}"/>
              </a:ext>
            </a:extLst>
          </p:cNvPr>
          <p:cNvSpPr txBox="1"/>
          <p:nvPr/>
        </p:nvSpPr>
        <p:spPr>
          <a:xfrm>
            <a:off x="4960068" y="2952919"/>
            <a:ext cx="536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799-10: Pat w, 51y, UNK, 3,9 mm, </a:t>
            </a:r>
            <a:r>
              <a:rPr lang="de-DE" sz="1400" dirty="0" err="1"/>
              <a:t>ulceration</a:t>
            </a:r>
            <a:r>
              <a:rPr lang="de-DE" sz="1400" dirty="0"/>
              <a:t>, Clark III, pT3b, pN1a, IIIC</a:t>
            </a:r>
          </a:p>
          <a:p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event</a:t>
            </a:r>
            <a:r>
              <a:rPr lang="de-DE" sz="1400" dirty="0"/>
              <a:t> 114m, follow-</a:t>
            </a:r>
            <a:r>
              <a:rPr lang="de-DE" sz="1400" dirty="0" err="1"/>
              <a:t>up</a:t>
            </a:r>
            <a:endParaRPr lang="de-DE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B135E77-95EA-2948-92DF-9EA2CA45BC59}"/>
              </a:ext>
            </a:extLst>
          </p:cNvPr>
          <p:cNvSpPr txBox="1"/>
          <p:nvPr/>
        </p:nvSpPr>
        <p:spPr>
          <a:xfrm>
            <a:off x="9422507" y="82712"/>
            <a:ext cx="230236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s, </a:t>
            </a:r>
            <a:r>
              <a:rPr lang="de-DE" b="1" dirty="0" err="1"/>
              <a:t>Figure</a:t>
            </a:r>
            <a:r>
              <a:rPr lang="de-DE" b="1" dirty="0"/>
              <a:t> 5</a:t>
            </a:r>
          </a:p>
          <a:p>
            <a:r>
              <a:rPr lang="en-US" dirty="0"/>
              <a:t>7-marker-signature </a:t>
            </a:r>
          </a:p>
          <a:p>
            <a:r>
              <a:rPr lang="en-US" dirty="0"/>
              <a:t>Low-risk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5258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6</Words>
  <Application>Microsoft Office PowerPoint</Application>
  <PresentationFormat>Breitbild</PresentationFormat>
  <Paragraphs>100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ke Seibold</dc:creator>
  <cp:lastModifiedBy>Ziemer, Mirjana</cp:lastModifiedBy>
  <cp:revision>44</cp:revision>
  <dcterms:created xsi:type="dcterms:W3CDTF">2021-02-01T11:07:25Z</dcterms:created>
  <dcterms:modified xsi:type="dcterms:W3CDTF">2021-06-09T19:49:47Z</dcterms:modified>
</cp:coreProperties>
</file>